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smtClean="0"/>
              <a:t>Klicka här för att ändra format på underrubrik i bakgrunden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668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848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364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478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838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007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640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566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165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145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76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414769-8C2B-499D-AFA4-6EDDDFF79B0B}" type="datetimeFigureOut">
              <a:rPr lang="en-US" smtClean="0"/>
              <a:t>7/5/2014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7B299-8A11-4B7D-B4A8-2D499AC8E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418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ruta 5"/>
          <p:cNvSpPr txBox="1"/>
          <p:nvPr/>
        </p:nvSpPr>
        <p:spPr>
          <a:xfrm>
            <a:off x="1892808" y="564918"/>
            <a:ext cx="870508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dditional file 3. The comparative distribution of the cell-type specific protein quantitative ratios. </a:t>
            </a:r>
            <a:r>
              <a:rPr lang="en-US" sz="1400" dirty="0"/>
              <a:t>The relative abundance and distribution of cell-type specific ratios (Log2) of all quantified proteins (Heterocysts/N</a:t>
            </a:r>
            <a:r>
              <a:rPr lang="en-US" sz="1400" baseline="-25000" dirty="0"/>
              <a:t>2</a:t>
            </a:r>
            <a:r>
              <a:rPr lang="en-US" sz="1400" dirty="0"/>
              <a:t>-fixing filaments) in cultures 24 hours after removal of combined nitrogen (present study) and from steady-state N</a:t>
            </a:r>
            <a:r>
              <a:rPr lang="en-US" sz="1400" baseline="-25000" dirty="0"/>
              <a:t>2</a:t>
            </a:r>
            <a:r>
              <a:rPr lang="en-US" sz="1400" dirty="0"/>
              <a:t>-fixing filaments [7].</a:t>
            </a:r>
          </a:p>
        </p:txBody>
      </p:sp>
      <p:pic>
        <p:nvPicPr>
          <p:cNvPr id="7" name="Bildobjekt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3767" y="1449432"/>
            <a:ext cx="7643169" cy="53354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67474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Bred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gustaf</dc:creator>
  <cp:lastModifiedBy>gustaf</cp:lastModifiedBy>
  <cp:revision>5</cp:revision>
  <dcterms:created xsi:type="dcterms:W3CDTF">2014-03-11T08:59:50Z</dcterms:created>
  <dcterms:modified xsi:type="dcterms:W3CDTF">2014-07-05T08:52:01Z</dcterms:modified>
</cp:coreProperties>
</file>